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91A9E0-7736-4625-A8A4-677D156AEE7C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EA97A4-3FE9-48F9-B589-30B73066F77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34671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Espace réservé de l'image des diapositives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7411" name="Espace réservé des commentaires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smtClean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41B45360-DBFC-4F7D-BD88-7353897FBAFF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57320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3471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22631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828904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95578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2318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42072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872439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79811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84912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20814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75925-BDFB-4179-A7AF-169E559B26B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12218-771C-4746-826E-654E1997DC7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04953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40" name="Group 168"/>
          <p:cNvGraphicFramePr>
            <a:graphicFrameLocks noGrp="1"/>
          </p:cNvGraphicFramePr>
          <p:nvPr>
            <p:ph idx="1"/>
          </p:nvPr>
        </p:nvGraphicFramePr>
        <p:xfrm>
          <a:off x="611188" y="398463"/>
          <a:ext cx="7921625" cy="5824529"/>
        </p:xfrm>
        <a:graphic>
          <a:graphicData uri="http://schemas.openxmlformats.org/drawingml/2006/table">
            <a:tbl>
              <a:tblPr/>
              <a:tblGrid>
                <a:gridCol w="1249362"/>
                <a:gridCol w="1514475"/>
                <a:gridCol w="1795463"/>
                <a:gridCol w="1795462"/>
                <a:gridCol w="1566863"/>
              </a:tblGrid>
              <a:tr h="32547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K metabolite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WT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L6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L8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L9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2318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gridSpan="4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pmol/ g FW</a:t>
                      </a:r>
                    </a:p>
                  </a:txBody>
                  <a:tcPr marL="8477" marR="8477" marT="847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1377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46.10 ± 2.71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1.36 ± 1.3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9.82 ± 0.7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28 ± 0.9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R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22 ±0.0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79 ± 0.2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24 ± 0.5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79 ± 0.3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DZ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8.31 ± 2.0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9.34 ± 0.9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22 ± 0.9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0.80 ± 4.2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DZR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40 ± 0.1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24 ± 0.0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46 ± 0.2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65 ± 0.1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iP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51 ± 0.3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10 ± 1.8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3.59 ± 1.4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2.93 ± 2.1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iPR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0.94 ± 2.7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6.00 ± 12.2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73 ± 0.7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0.45 ± 5.8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8.64 ± 2.6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12 ± 1.3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.81 ± 0.1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58 ± 0.3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R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39 ± 0.41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21 ± 0.41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58 ± 0.1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39 ± 0.2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O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25 ± 0.1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ND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ND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42 ± 0.0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RO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.52 ± 1.1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8.60 ± 2.0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4.45 ± 1.7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.81 ± 0.6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DHZRO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18 ± 3.0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46 ± 2.2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36 ± 0.6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.59 ± 2.9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O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.24 ± 0.7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2.48 ± 3.5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2.86 ± 1.6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6.54 ± 0.6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RO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38 ± 0.6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31 ± 0.1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7.23 ± 1.6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28 ± 0.3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7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37.11 ± 2.3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898.89 ± 10.5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446.52 ± 7.1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832.64 ± 10.4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9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2.69 ± 2.5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3.22 ± 2.6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3.84 ± 2.3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9.74 ± 2.3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DZ9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28 ± 0.3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19 ± 0.7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62 ± 0.3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67 ± 0.2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7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63.66 ± 10.1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66.33 ± 11.2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51.01 ± 20.2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64.36 ± 12.00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9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03 ±  0.01 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39 ±  0.0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.83 ± 0.5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14 ±  0.0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iP7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771.41 ± 43.4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4050.11 ± 1316.3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6518</a:t>
                      </a: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</a:rPr>
                        <a:t>.</a:t>
                      </a: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4 ± 1639.0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8369</a:t>
                      </a: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</a:rPr>
                        <a:t>.</a:t>
                      </a: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96 ± 2009.4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iP9G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71 ± 0.1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6.05 ± 1.7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0.30 ± 0.3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1.95 ± 0.15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ZRMP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07 ± 0.0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03 ± 0.01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31 ± 0.6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39 ± 0.96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cZRMP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30 ± 0.19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25 ± 0.0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0.13 ± 0.01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.21 ± 0.7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IPRMP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22.39 ± 24.48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3482.68 ± 87.0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19.18 ± 2.7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52.91 ± 7.3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20690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2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total CKs</a:t>
                      </a:r>
                      <a:endParaRPr kumimoji="0" lang="cs-CZ" altLang="cs-CZ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Arial" pitchFamily="34" charset="0"/>
                      </a:endParaRP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413.72 ± 100.44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8959.52 ± 1457.03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7353.39 ± 1684.17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s-CZ" altLang="cs-CZ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Arial" pitchFamily="34" charset="0"/>
                        </a:rPr>
                        <a:t>29775.44 ± 2062.62</a:t>
                      </a:r>
                    </a:p>
                  </a:txBody>
                  <a:tcPr marL="8477" marR="8477" marT="8474" marB="0" anchor="b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  <p:sp>
        <p:nvSpPr>
          <p:cNvPr id="6310" name="TextovéPole 1"/>
          <p:cNvSpPr txBox="1">
            <a:spLocks noChangeArrowheads="1"/>
          </p:cNvSpPr>
          <p:nvPr/>
        </p:nvSpPr>
        <p:spPr bwMode="auto">
          <a:xfrm>
            <a:off x="0" y="6369050"/>
            <a:ext cx="9144000" cy="27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 typeface="Arial" charset="0"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5. Endogenous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CK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content (pmol/ g fresh weight) in 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young 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leaves of T0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35S::SlIPT3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 tomato</a:t>
            </a:r>
            <a:r>
              <a:rPr lang="fr-FR" altLang="cs-CZ" sz="1200" b="1">
                <a:latin typeface="Helvetica" pitchFamily="34" charset="0"/>
                <a:cs typeface="Helvetica" pitchFamily="34" charset="0"/>
              </a:rPr>
              <a:t>es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0133534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5</Words>
  <Application>Microsoft Office PowerPoint</Application>
  <PresentationFormat>Předvádění na obrazovce (4:3)</PresentationFormat>
  <Paragraphs>128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2:13Z</dcterms:created>
  <dcterms:modified xsi:type="dcterms:W3CDTF">2014-10-10T16:02:42Z</dcterms:modified>
</cp:coreProperties>
</file>